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fa-I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RT Pack 20 DVDs" initials="MP2D" lastIdx="1" clrIdx="0">
    <p:extLst>
      <p:ext uri="{19B8F6BF-5375-455C-9EA6-DF929625EA0E}">
        <p15:presenceInfo xmlns:p15="http://schemas.microsoft.com/office/powerpoint/2012/main" userId="MRT Pack 20 DVDs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2466" autoAdjust="0"/>
  </p:normalViewPr>
  <p:slideViewPr>
    <p:cSldViewPr snapToGrid="0">
      <p:cViewPr varScale="1">
        <p:scale>
          <a:sx n="68" d="100"/>
          <a:sy n="68" d="100"/>
        </p:scale>
        <p:origin x="1234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fa-I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3582F1FA-6D48-448C-970A-66BE609E95DD}" type="datetimeFigureOut">
              <a:rPr lang="fa-IR" smtClean="0"/>
              <a:t>27/10/1445</a:t>
            </a:fld>
            <a:endParaRPr lang="fa-I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a-I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3C074EB9-6B0F-4569-A951-7A63C87761FC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6347501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074EB9-6B0F-4569-A951-7A63C87761FC}" type="slidenum">
              <a:rPr lang="fa-IR" smtClean="0"/>
              <a:t>1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8432818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7/10/1445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499234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7/10/1445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561788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7/10/1445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754041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7/10/1445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367169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7/10/1445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104283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7/10/1445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438717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7/10/1445</a:t>
            </a:fld>
            <a:endParaRPr lang="fa-I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189703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7/10/1445</a:t>
            </a:fld>
            <a:endParaRPr lang="fa-I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69286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7/10/1445</a:t>
            </a:fld>
            <a:endParaRPr lang="fa-I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5406404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7/10/1445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2002215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a-I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7/10/1445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628824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3623DA-C239-499A-8DAB-661F72BF1177}" type="datetimeFigureOut">
              <a:rPr lang="fa-IR" smtClean="0"/>
              <a:t>27/10/1445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056540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a-I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69782" y="5623629"/>
            <a:ext cx="11052436" cy="92333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+mj-cs"/>
              </a:rPr>
              <a:t>Fig S2. </a:t>
            </a:r>
            <a:r>
              <a:rPr lang="en-US" dirty="0">
                <a:latin typeface="Times New Roman" panose="02020603050405020304" pitchFamily="18" charset="0"/>
                <a:cs typeface="+mj-cs"/>
              </a:rPr>
              <a:t>Monitoring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the number of disulfide bonds (DB).</a:t>
            </a:r>
            <a:r>
              <a:rPr lang="fa-I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egistering the number one and zero against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B_state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indicates the presence and absence of disulfide bonds, respectively.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B_conf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represents the confidence factor. The closer the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B_conf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number to 9,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represents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higher confidence level.</a:t>
            </a:r>
            <a:endParaRPr lang="fa-IR" dirty="0">
              <a:latin typeface="Times New Roman" panose="02020603050405020304" pitchFamily="18" charset="0"/>
              <a:cs typeface="+mj-cs"/>
            </a:endParaRPr>
          </a:p>
        </p:txBody>
      </p:sp>
      <p:pic>
        <p:nvPicPr>
          <p:cNvPr id="2049" name="Picture 3">
            <a:extLst>
              <a:ext uri="{FF2B5EF4-FFF2-40B4-BE49-F238E27FC236}">
                <a16:creationId xmlns:a16="http://schemas.microsoft.com/office/drawing/2014/main" id="{6EF16276-D889-DBA9-4D3B-5263F86E0FB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986" y="220730"/>
            <a:ext cx="11153018" cy="49371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ADD789F2-A6A1-C3E1-607A-6B3074908C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6" name="Rectangle 4">
            <a:extLst>
              <a:ext uri="{FF2B5EF4-FFF2-40B4-BE49-F238E27FC236}">
                <a16:creationId xmlns:a16="http://schemas.microsoft.com/office/drawing/2014/main" id="{FE93E193-7713-E74C-73A7-22365733FB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096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7" name="Rectangle 5">
            <a:extLst>
              <a:ext uri="{FF2B5EF4-FFF2-40B4-BE49-F238E27FC236}">
                <a16:creationId xmlns:a16="http://schemas.microsoft.com/office/drawing/2014/main" id="{4083DB81-53F0-B785-013E-8699AA9271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298767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751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51</TotalTime>
  <Words>58</Words>
  <Application>Microsoft Office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RT www.Win2Farsi.co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RT Pack 20 DVDs</dc:creator>
  <cp:lastModifiedBy>red pc</cp:lastModifiedBy>
  <cp:revision>85</cp:revision>
  <dcterms:created xsi:type="dcterms:W3CDTF">2019-03-24T09:48:42Z</dcterms:created>
  <dcterms:modified xsi:type="dcterms:W3CDTF">2024-05-05T13:15:01Z</dcterms:modified>
</cp:coreProperties>
</file>